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-240" y="-142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80050681-A6E7-CB34-776C-A39448932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="" xmlns:a16="http://schemas.microsoft.com/office/drawing/2014/main" id="{B72927D1-72F9-3937-65BB-BC2D5CF3D89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B7FFD7E8-8911-5351-E2CE-F6E43811AC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C65C6ADA-DF1A-22A7-389D-48B49E826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9286EA4A-99FC-AE9D-E08A-9E6BCE41D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68078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70942C-1F5F-C0B1-C660-EED1689FAD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F7A6F098-3AE5-49DF-F65D-2343EEB7FF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019F7976-9D0C-EDD2-4C13-A76724BDD3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43F07E5B-6C33-5E41-A73F-960A50586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5416937-6BAF-D56B-AC22-EFFC83807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160416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="" xmlns:a16="http://schemas.microsoft.com/office/drawing/2014/main" id="{8AEBD049-29D2-C7E4-0FA7-4CB5B0E9256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="" xmlns:a16="http://schemas.microsoft.com/office/drawing/2014/main" id="{81775499-822A-1621-FF9C-9541677513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842DCA56-F96C-1D02-23A3-952C52C6B9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7C23E8F8-3995-5AA5-E538-1D7767F57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681A1687-6E0E-B5A1-1E47-BDB5D55E3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2967918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D8AFF0F-5700-B26D-6510-E4B5812521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C2616D5E-F700-2C5B-2525-D9ABBA32FA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B6F5DD9-7D53-1F8E-F8AB-03C3596A0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BEF23A49-E9C4-4C96-6225-E9A89D961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7A5B151E-E8EA-32ED-F282-DB4295BCC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2677565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4FAC267D-330B-F6AF-4194-8CB242E89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CEC20DB7-BF07-D2EB-CBEE-8BEF5DA202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D2D12727-0D8C-0D98-E2D9-8D5A8DB92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D72BD71C-EDB5-6022-A4E0-4B399797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C720F283-4064-E1C7-CA01-158A50CB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7910777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8696025-4BA6-501D-A54D-573AA70F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6593ACB2-7908-2D5F-7A5A-67103E6F22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39B666E6-8B5D-4A84-E584-76E0313E90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E18E3FE3-CE0E-6BBE-1373-B4FF91DB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D6B99DBB-D291-B70F-51C5-6DCDC658D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0A93378-1089-DAD4-CBF2-5E2FC5DF56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732500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A6820180-2B1F-7E86-1C85-028489FD2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EEA8BD1E-7645-FAF4-9F72-EF8F78D4F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="" xmlns:a16="http://schemas.microsoft.com/office/drawing/2014/main" id="{E92BEE2D-3AFB-C625-6DE2-8C76C27EB4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="" xmlns:a16="http://schemas.microsoft.com/office/drawing/2014/main" id="{D48BAEFA-4424-02C9-EB89-03A28F2BCD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="" xmlns:a16="http://schemas.microsoft.com/office/drawing/2014/main" id="{15C41A3B-AA13-F21F-B349-2478C82EDE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="" xmlns:a16="http://schemas.microsoft.com/office/drawing/2014/main" id="{F0582415-56DC-B170-CDF0-BE62EFA9A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="" xmlns:a16="http://schemas.microsoft.com/office/drawing/2014/main" id="{9D6EFAC7-B063-911F-7F4E-3F19049E3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="" xmlns:a16="http://schemas.microsoft.com/office/drawing/2014/main" id="{8615E53A-1EF6-4E23-2F17-469E4F077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0892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B1CE2-671B-89DF-FD96-BF399AC6C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="" xmlns:a16="http://schemas.microsoft.com/office/drawing/2014/main" id="{CD966B3B-14C6-4C2A-8BCF-5AC15AF6A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="" xmlns:a16="http://schemas.microsoft.com/office/drawing/2014/main" id="{61EE871A-067C-4449-D4D3-F240132B7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="" xmlns:a16="http://schemas.microsoft.com/office/drawing/2014/main" id="{2A2DFCB0-E29A-AD2B-14A6-DCD6F79FD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125285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="" xmlns:a16="http://schemas.microsoft.com/office/drawing/2014/main" id="{B326F172-39F4-44FD-B858-0F4FEDB34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="" xmlns:a16="http://schemas.microsoft.com/office/drawing/2014/main" id="{843C5D89-BAEB-7FB1-8323-6A4F11E545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="" xmlns:a16="http://schemas.microsoft.com/office/drawing/2014/main" id="{1D54F48A-EF69-D74B-2200-1351DE33D6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117553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FE32B685-E62F-17A9-476C-E14014806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D605308-4383-0779-8E55-0E3B027A4E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7A7238C4-3A51-1C78-931B-E7B73742486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CE62676F-B03B-3404-BCF7-7B822770B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889DEF69-5A9D-EEB3-C2A4-12A9C7E14D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FEB9A95A-8412-41DC-FA9A-3C907742CE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576501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C0C8E5B2-EBF3-EF94-A6C4-A37CD31B5E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="" xmlns:a16="http://schemas.microsoft.com/office/drawing/2014/main" id="{67A90359-6F91-3B96-CED3-CF304C4EC6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="" xmlns:a16="http://schemas.microsoft.com/office/drawing/2014/main" id="{A387EA31-F8C7-732C-072D-3497177640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="" xmlns:a16="http://schemas.microsoft.com/office/drawing/2014/main" id="{8147160C-4191-6406-5182-FCE5EE9E01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="" xmlns:a16="http://schemas.microsoft.com/office/drawing/2014/main" id="{FAAAC055-D406-0213-2907-8A8DFC6845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="" xmlns:a16="http://schemas.microsoft.com/office/drawing/2014/main" id="{94D46E60-6FCF-8EBF-1455-9BA07E3D9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043807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2F918E65-B4F6-4D4B-15CA-EB4E976DC2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="" xmlns:a16="http://schemas.microsoft.com/office/drawing/2014/main" id="{D3EE80B9-9D15-32B0-2C6B-B0B4CBC751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="" xmlns:a16="http://schemas.microsoft.com/office/drawing/2014/main" id="{7F19557F-66E9-9344-74A8-C96C42B184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234611-1632-4DF2-9A39-7C6AEF690B47}" type="datetimeFigureOut">
              <a:rPr lang="ru-RU" smtClean="0"/>
              <a:t>14.01.2025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="" xmlns:a16="http://schemas.microsoft.com/office/drawing/2014/main" id="{A93133E5-9E8B-012A-757F-3101932A868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="" xmlns:a16="http://schemas.microsoft.com/office/drawing/2014/main" id="{8FEEC80B-B08C-A809-F323-54607FFDD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C02C66-AC76-48EC-973B-B52E5F00D138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45693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="" xmlns:a16="http://schemas.microsoft.com/office/drawing/2014/main" id="{54D09361-B79C-DFC0-0777-9FBA893FA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5438" y="99951"/>
            <a:ext cx="7886700" cy="476123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Real-time reverse transcription polymerase chain reaction (RT-PCR) verification of the RNA-Seq results.</a:t>
            </a:r>
            <a:endParaRPr lang="ru-RU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Объект 2">
            <a:extLst>
              <a:ext uri="{FF2B5EF4-FFF2-40B4-BE49-F238E27FC236}">
                <a16:creationId xmlns="" xmlns:a16="http://schemas.microsoft.com/office/drawing/2014/main" id="{B5A1926C-F1CF-5BDA-0061-F4962B0CEC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55448" y="5943600"/>
            <a:ext cx="8862822" cy="792480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1400" dirty="0" smtClean="0"/>
              <a:t>Data </a:t>
            </a:r>
            <a:r>
              <a:rPr lang="en-GB" sz="1400" dirty="0"/>
              <a:t>for the comparison between IR-s and SO-s are shown. Reference mRNAs </a:t>
            </a:r>
            <a:r>
              <a:rPr lang="en-GB" sz="1400" i="1" dirty="0" err="1"/>
              <a:t>Gapdh</a:t>
            </a:r>
            <a:r>
              <a:rPr lang="en-GB" sz="1400" dirty="0"/>
              <a:t> was used to normalize the PCR results. Each group included at least five rats. The data are presented as the mean ± standard error of the mean (SEM</a:t>
            </a:r>
            <a:r>
              <a:rPr lang="en-GB" sz="1400" dirty="0" smtClean="0"/>
              <a:t>).</a:t>
            </a:r>
            <a:endParaRPr lang="en-US" sz="16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K:\Редактируемые\Для публикаций\0_текущие публикации\ишемия_2\стриатум 24h\статья по 24 часам striat\1_IR Str-FC\fs2-1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6589" y="1546860"/>
            <a:ext cx="4576413" cy="31927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2803779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55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Figure S2. Real-time reverse transcription polymerase chain reaction (RT-PCR) verification of the RNA-Seq results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1. Real-time reverse transcription polymerase chain reaction (RT-PCR) verification of the RNA-Seq results.</dc:title>
  <dc:creator>Maria Manor</dc:creator>
  <cp:lastModifiedBy>Ivan</cp:lastModifiedBy>
  <cp:revision>8</cp:revision>
  <dcterms:created xsi:type="dcterms:W3CDTF">2023-01-16T11:00:34Z</dcterms:created>
  <dcterms:modified xsi:type="dcterms:W3CDTF">2025-01-14T07:49:48Z</dcterms:modified>
</cp:coreProperties>
</file>